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6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116" d="100"/>
          <a:sy n="116" d="100"/>
        </p:scale>
        <p:origin x="8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rypotou, Aimilia" userId="3383a474-3fc2-4c30-947f-c16ae8f712c0" providerId="ADAL" clId="{5F58C162-B99F-A64F-9213-E50724F0E059}"/>
    <pc:docChg chg="delSld">
      <pc:chgData name="Krypotou, Aimilia" userId="3383a474-3fc2-4c30-947f-c16ae8f712c0" providerId="ADAL" clId="{5F58C162-B99F-A64F-9213-E50724F0E059}" dt="2025-12-29T17:56:20.762" v="7" actId="2696"/>
      <pc:docMkLst>
        <pc:docMk/>
      </pc:docMkLst>
      <pc:sldChg chg="del">
        <pc:chgData name="Krypotou, Aimilia" userId="3383a474-3fc2-4c30-947f-c16ae8f712c0" providerId="ADAL" clId="{5F58C162-B99F-A64F-9213-E50724F0E059}" dt="2025-12-29T17:56:18.941" v="6" actId="2696"/>
        <pc:sldMkLst>
          <pc:docMk/>
          <pc:sldMk cId="3552300620" sldId="256"/>
        </pc:sldMkLst>
      </pc:sldChg>
      <pc:sldChg chg="del">
        <pc:chgData name="Krypotou, Aimilia" userId="3383a474-3fc2-4c30-947f-c16ae8f712c0" providerId="ADAL" clId="{5F58C162-B99F-A64F-9213-E50724F0E059}" dt="2025-12-29T17:56:18.303" v="5" actId="2696"/>
        <pc:sldMkLst>
          <pc:docMk/>
          <pc:sldMk cId="2809017152" sldId="257"/>
        </pc:sldMkLst>
      </pc:sldChg>
      <pc:sldChg chg="del">
        <pc:chgData name="Krypotou, Aimilia" userId="3383a474-3fc2-4c30-947f-c16ae8f712c0" providerId="ADAL" clId="{5F58C162-B99F-A64F-9213-E50724F0E059}" dt="2025-12-29T17:56:17.497" v="4" actId="2696"/>
        <pc:sldMkLst>
          <pc:docMk/>
          <pc:sldMk cId="3412642638" sldId="258"/>
        </pc:sldMkLst>
      </pc:sldChg>
      <pc:sldChg chg="del">
        <pc:chgData name="Krypotou, Aimilia" userId="3383a474-3fc2-4c30-947f-c16ae8f712c0" providerId="ADAL" clId="{5F58C162-B99F-A64F-9213-E50724F0E059}" dt="2025-12-29T17:56:20.762" v="7" actId="2696"/>
        <pc:sldMkLst>
          <pc:docMk/>
          <pc:sldMk cId="1939867441" sldId="259"/>
        </pc:sldMkLst>
      </pc:sldChg>
      <pc:sldChg chg="del">
        <pc:chgData name="Krypotou, Aimilia" userId="3383a474-3fc2-4c30-947f-c16ae8f712c0" providerId="ADAL" clId="{5F58C162-B99F-A64F-9213-E50724F0E059}" dt="2025-12-29T17:56:16.788" v="3" actId="2696"/>
        <pc:sldMkLst>
          <pc:docMk/>
          <pc:sldMk cId="1686765377" sldId="260"/>
        </pc:sldMkLst>
      </pc:sldChg>
      <pc:sldChg chg="del">
        <pc:chgData name="Krypotou, Aimilia" userId="3383a474-3fc2-4c30-947f-c16ae8f712c0" providerId="ADAL" clId="{5F58C162-B99F-A64F-9213-E50724F0E059}" dt="2025-12-29T17:56:13.573" v="0" actId="2696"/>
        <pc:sldMkLst>
          <pc:docMk/>
          <pc:sldMk cId="2855954256" sldId="263"/>
        </pc:sldMkLst>
      </pc:sldChg>
      <pc:sldChg chg="del">
        <pc:chgData name="Krypotou, Aimilia" userId="3383a474-3fc2-4c30-947f-c16ae8f712c0" providerId="ADAL" clId="{5F58C162-B99F-A64F-9213-E50724F0E059}" dt="2025-12-29T17:56:14.339" v="1" actId="2696"/>
        <pc:sldMkLst>
          <pc:docMk/>
          <pc:sldMk cId="953867029" sldId="264"/>
        </pc:sldMkLst>
      </pc:sldChg>
      <pc:sldChg chg="del">
        <pc:chgData name="Krypotou, Aimilia" userId="3383a474-3fc2-4c30-947f-c16ae8f712c0" providerId="ADAL" clId="{5F58C162-B99F-A64F-9213-E50724F0E059}" dt="2025-12-29T17:56:14.817" v="2" actId="2696"/>
        <pc:sldMkLst>
          <pc:docMk/>
          <pc:sldMk cId="3450662349" sldId="26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39B4D-ECF8-792D-1E8E-DF17ECEED5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D0879E-100B-DECF-ADC4-DD144A9F53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17B0E5-B386-FA8C-5E4D-D1C5BF27B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5C8D2-18BF-6595-722E-6999D7A365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2F598-7557-0892-70CE-037BE38C9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16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9735B9-A882-17DE-166E-1FFC527ED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95B352-0CB7-C535-D0A0-BC54E1A56D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903C03-7066-EBE1-1117-4E84E2D84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1619AD-FEE7-1E7C-46DE-0FE11435E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900E21-AE59-584E-7CB2-61FC62D50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694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B058CB-508B-7C04-5F5D-165C615F30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4EE964-EC5F-1496-5CE4-A672AE858A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09E7AE-59BD-B6A7-2DE5-B720CDD64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45B330-05E5-99FB-0CA9-A7ABDE40F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9482F0-523B-58BB-D7B0-F9044F67B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862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31038-98AD-FC0F-B704-751CF229D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AF3291-B390-0786-33A3-CFDB085817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44927B-6AC0-2DEB-AE94-7CA7419E7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8DE34D-7DD7-54E8-A497-8DDE42296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54AF8E-1C5E-75CC-323B-31B1E01C1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FFB8A-E374-BC4D-7A8B-7300C78D5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95A331-2912-E524-05E2-0F6E4A65B8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92109-A65E-FBCC-7828-B5B8B5E09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D297F6-7F01-7243-AB92-3F1929F38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98FB16-81D5-5FE7-DFC5-DCCD5D8E5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897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F1EEE-0322-6F4E-76BA-966DD2197F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046413-ABAD-9B9F-6E90-2136C73EF3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CCB1C5-26ED-762B-589D-0A29D69A52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9FA54-F6D7-96A7-5C81-5AAA11200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6AB86B-673B-D28A-5501-AD67EFB74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6AF430-F379-5012-0955-9A6C42F54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379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4A211F-1FAA-0E9E-4E93-9D596DC6FB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3BA49A-7628-A281-B85B-499DADD6D1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FA5670-B4A0-74D4-66B0-88CF9F2723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AF9B0AF-10FC-1265-A51C-9F68991AE1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4707EC-24D8-84D4-C76E-AEE7DF571C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FF2908-DCD4-2604-0388-8E7AFF8D1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C54A6C-1F79-4262-6103-698FBAC93B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57B865-B32C-25E7-8180-3E3912AB3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750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D06E56-0866-6FAB-15C3-FC50CEED47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B36E4A-366D-B46F-E3A6-32ADFC459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4B04D4-8C00-3F8A-1750-0BEFBEC4D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2AD13E-4F97-AA98-E7E0-8082112405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71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E0B539-3FD6-D832-DB3E-0B793AEA4F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28AD91-3200-ECA6-A1B1-95D01552D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0CFF6B-067B-5DC6-F9CB-3B837B741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983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1A002-F5AB-6B48-2E07-B610C66BF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961A05-5520-38A9-5BFC-CE245ECBB3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50FDCE-7FF9-762F-2B0E-2D6A830C31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5CCA21-BC9B-7F6B-8196-F4501BB73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E904E3-882B-C825-D389-1037BC0F3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CBEC86-FB13-F957-46C1-ECD34AD5B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885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EC99E-E26C-F422-1CE4-B16CF38EC9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4728B2-D16D-9B9D-32F6-34ABAA451C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157CE5-0FDC-489A-8472-CC0C9411E1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B9FF73-8F4D-C276-0B53-1F8DFFA26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F63DC4-639C-A347-5BE9-41CEEA2E0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0B7E76-6F50-1272-E45E-779FFC750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89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CB923C-6F2D-B027-721B-FF049C83D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6A7E17-8CE2-2D48-E320-11053EAD0A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D5C985-63C8-D967-1940-EFFB825508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A31E9A3-C369-8A45-9420-B7039B0EA2E6}" type="datetimeFigureOut">
              <a:rPr lang="en-US" smtClean="0"/>
              <a:t>12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07093-3A49-1398-E7D3-63464BED73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812A23-3A34-9736-5C1E-11D8A5FB94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2F286C-8373-5142-8DEF-CC99DBA7B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777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EF7C3AF7-5548-EAE1-C5C6-60FA7BD6F9A7}"/>
              </a:ext>
            </a:extLst>
          </p:cNvPr>
          <p:cNvSpPr txBox="1"/>
          <p:nvPr/>
        </p:nvSpPr>
        <p:spPr>
          <a:xfrm>
            <a:off x="625033" y="358815"/>
            <a:ext cx="374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E motif mutants with </a:t>
            </a:r>
            <a:r>
              <a:rPr lang="en-US" dirty="0" err="1"/>
              <a:t>ppGpp</a:t>
            </a:r>
            <a:endParaRPr lang="en-US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A09E511-E93C-4142-C3BB-FB8F7291BF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1813" y="1619385"/>
            <a:ext cx="1816136" cy="3396706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920E398-308F-31FC-E48D-2A80BA824CDB}"/>
              </a:ext>
            </a:extLst>
          </p:cNvPr>
          <p:cNvCxnSpPr>
            <a:cxnSpLocks/>
          </p:cNvCxnSpPr>
          <p:nvPr/>
        </p:nvCxnSpPr>
        <p:spPr>
          <a:xfrm>
            <a:off x="3215164" y="1619385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6064456B-3F85-B305-347D-1D18E719651B}"/>
              </a:ext>
            </a:extLst>
          </p:cNvPr>
          <p:cNvSpPr txBox="1"/>
          <p:nvPr/>
        </p:nvSpPr>
        <p:spPr>
          <a:xfrm>
            <a:off x="3217569" y="1260916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BFA98DE-91FA-86E0-60BE-2DE59B57C890}"/>
              </a:ext>
            </a:extLst>
          </p:cNvPr>
          <p:cNvSpPr txBox="1"/>
          <p:nvPr/>
        </p:nvSpPr>
        <p:spPr>
          <a:xfrm>
            <a:off x="1480931" y="1755193"/>
            <a:ext cx="1534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FCB922F-9E20-0C5F-A1C3-05640DA2A3C8}"/>
              </a:ext>
            </a:extLst>
          </p:cNvPr>
          <p:cNvSpPr txBox="1"/>
          <p:nvPr/>
        </p:nvSpPr>
        <p:spPr>
          <a:xfrm>
            <a:off x="1309410" y="2234768"/>
            <a:ext cx="1705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ED0B51B-A55F-28E1-8CFD-FDF6265A9F28}"/>
              </a:ext>
            </a:extLst>
          </p:cNvPr>
          <p:cNvSpPr txBox="1"/>
          <p:nvPr/>
        </p:nvSpPr>
        <p:spPr>
          <a:xfrm>
            <a:off x="802861" y="2652248"/>
            <a:ext cx="221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PLDmotif</a:t>
            </a:r>
            <a:r>
              <a:rPr lang="en-US" dirty="0"/>
              <a:t> Rh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71D03A6-D767-75B3-3901-208CFAAAF3E3}"/>
              </a:ext>
            </a:extLst>
          </p:cNvPr>
          <p:cNvSpPr txBox="1"/>
          <p:nvPr/>
        </p:nvSpPr>
        <p:spPr>
          <a:xfrm>
            <a:off x="1057737" y="3085526"/>
            <a:ext cx="1957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motif</a:t>
            </a:r>
            <a:r>
              <a:rPr lang="en-US" dirty="0"/>
              <a:t> Rh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91B1215-9460-BE62-F3F0-FD204F72532A}"/>
              </a:ext>
            </a:extLst>
          </p:cNvPr>
          <p:cNvSpPr txBox="1"/>
          <p:nvPr/>
        </p:nvSpPr>
        <p:spPr>
          <a:xfrm>
            <a:off x="1155146" y="3515805"/>
            <a:ext cx="1872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k1-88 Rho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6977E53-B977-0209-2BD1-9F29FF4F307A}"/>
              </a:ext>
            </a:extLst>
          </p:cNvPr>
          <p:cNvSpPr txBox="1"/>
          <p:nvPr/>
        </p:nvSpPr>
        <p:spPr>
          <a:xfrm>
            <a:off x="625033" y="4374588"/>
            <a:ext cx="24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Binding buffer only -c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75D239F-F855-362D-5EC5-F3126E205DA1}"/>
              </a:ext>
            </a:extLst>
          </p:cNvPr>
          <p:cNvSpPr txBox="1"/>
          <p:nvPr/>
        </p:nvSpPr>
        <p:spPr>
          <a:xfrm>
            <a:off x="921108" y="3916478"/>
            <a:ext cx="210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k89-176 Rho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2ACBD3D-4644-F30E-EBEF-0BE90A5EA163}"/>
              </a:ext>
            </a:extLst>
          </p:cNvPr>
          <p:cNvSpPr txBox="1"/>
          <p:nvPr/>
        </p:nvSpPr>
        <p:spPr>
          <a:xfrm>
            <a:off x="447157" y="5165842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1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1D75691-D7D5-C2CB-32DC-876B2E451A2E}"/>
              </a:ext>
            </a:extLst>
          </p:cNvPr>
          <p:cNvCxnSpPr>
            <a:cxnSpLocks/>
          </p:cNvCxnSpPr>
          <p:nvPr/>
        </p:nvCxnSpPr>
        <p:spPr>
          <a:xfrm>
            <a:off x="8609434" y="1490280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D129E00F-4A93-9C8A-8FC4-76CBA9AD4CE9}"/>
              </a:ext>
            </a:extLst>
          </p:cNvPr>
          <p:cNvSpPr txBox="1"/>
          <p:nvPr/>
        </p:nvSpPr>
        <p:spPr>
          <a:xfrm>
            <a:off x="8611839" y="1131811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955EB33-8E96-644E-DDFD-8AD492F93548}"/>
              </a:ext>
            </a:extLst>
          </p:cNvPr>
          <p:cNvSpPr txBox="1"/>
          <p:nvPr/>
        </p:nvSpPr>
        <p:spPr>
          <a:xfrm>
            <a:off x="6875201" y="1626088"/>
            <a:ext cx="1534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F20FDCDC-29C0-B7AF-75AF-56036E0FDA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09434" y="1501143"/>
            <a:ext cx="1705916" cy="3242777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31501A31-848D-D368-00E1-009B826ACAE4}"/>
              </a:ext>
            </a:extLst>
          </p:cNvPr>
          <p:cNvSpPr txBox="1"/>
          <p:nvPr/>
        </p:nvSpPr>
        <p:spPr>
          <a:xfrm>
            <a:off x="6703680" y="2105663"/>
            <a:ext cx="1705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CFFBD13-6077-5012-079C-1959DC7F70FD}"/>
              </a:ext>
            </a:extLst>
          </p:cNvPr>
          <p:cNvSpPr txBox="1"/>
          <p:nvPr/>
        </p:nvSpPr>
        <p:spPr>
          <a:xfrm>
            <a:off x="6197131" y="2523143"/>
            <a:ext cx="221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PLDmotif</a:t>
            </a:r>
            <a:r>
              <a:rPr lang="en-US" dirty="0"/>
              <a:t> Rho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E2746EF-9C36-67C1-C25F-D564D4D73218}"/>
              </a:ext>
            </a:extLst>
          </p:cNvPr>
          <p:cNvSpPr txBox="1"/>
          <p:nvPr/>
        </p:nvSpPr>
        <p:spPr>
          <a:xfrm>
            <a:off x="6452007" y="2956421"/>
            <a:ext cx="1957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motif</a:t>
            </a:r>
            <a:r>
              <a:rPr lang="en-US" dirty="0"/>
              <a:t> Rho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EDD2DD6-BFFD-2F80-FFFB-2CA9903DF6E1}"/>
              </a:ext>
            </a:extLst>
          </p:cNvPr>
          <p:cNvSpPr txBox="1"/>
          <p:nvPr/>
        </p:nvSpPr>
        <p:spPr>
          <a:xfrm>
            <a:off x="6549416" y="3386700"/>
            <a:ext cx="1872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k1-88 Rho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CF332C6-82B1-75A6-711E-554BB69B0477}"/>
              </a:ext>
            </a:extLst>
          </p:cNvPr>
          <p:cNvSpPr txBox="1"/>
          <p:nvPr/>
        </p:nvSpPr>
        <p:spPr>
          <a:xfrm>
            <a:off x="6019303" y="4245483"/>
            <a:ext cx="24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Binding buffer only -co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E370AB8-1A49-FA5D-9667-5321AD95ACC4}"/>
              </a:ext>
            </a:extLst>
          </p:cNvPr>
          <p:cNvSpPr txBox="1"/>
          <p:nvPr/>
        </p:nvSpPr>
        <p:spPr>
          <a:xfrm>
            <a:off x="6315378" y="3787373"/>
            <a:ext cx="210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k89-176 Rho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582BFE4-FBA8-F1E0-3C39-F30AFC1061DA}"/>
              </a:ext>
            </a:extLst>
          </p:cNvPr>
          <p:cNvSpPr txBox="1"/>
          <p:nvPr/>
        </p:nvSpPr>
        <p:spPr>
          <a:xfrm>
            <a:off x="7446584" y="5051603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2</a:t>
            </a:r>
          </a:p>
        </p:txBody>
      </p:sp>
    </p:spTree>
    <p:extLst>
      <p:ext uri="{BB962C8B-B14F-4D97-AF65-F5344CB8AC3E}">
        <p14:creationId xmlns:p14="http://schemas.microsoft.com/office/powerpoint/2010/main" val="24041634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36190AD-ED8C-18F6-1B77-EF1FD51D85E3}"/>
              </a:ext>
            </a:extLst>
          </p:cNvPr>
          <p:cNvSpPr txBox="1"/>
          <p:nvPr/>
        </p:nvSpPr>
        <p:spPr>
          <a:xfrm>
            <a:off x="625033" y="358815"/>
            <a:ext cx="374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E motif mutants with </a:t>
            </a:r>
            <a:r>
              <a:rPr lang="en-US" dirty="0" err="1"/>
              <a:t>ppGpp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BC84B5A-BC0D-5AEC-EFF5-DEE581A8F6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1614" y="1599332"/>
            <a:ext cx="1349839" cy="3734830"/>
          </a:xfrm>
          <a:prstGeom prst="rect">
            <a:avLst/>
          </a:prstGeom>
        </p:spPr>
      </p:pic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9937039-BA17-75C4-E3FE-ADC741B4A8B0}"/>
              </a:ext>
            </a:extLst>
          </p:cNvPr>
          <p:cNvCxnSpPr>
            <a:cxnSpLocks/>
          </p:cNvCxnSpPr>
          <p:nvPr/>
        </p:nvCxnSpPr>
        <p:spPr>
          <a:xfrm>
            <a:off x="3552547" y="1897177"/>
            <a:ext cx="178293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E8285C6C-5D57-E23B-90FC-8B35FD611D41}"/>
              </a:ext>
            </a:extLst>
          </p:cNvPr>
          <p:cNvSpPr txBox="1"/>
          <p:nvPr/>
        </p:nvSpPr>
        <p:spPr>
          <a:xfrm>
            <a:off x="3554952" y="1538708"/>
            <a:ext cx="1830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0.025nM *ppGp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9B15F6-7EA9-DF5B-D17E-1F0A4F6B4997}"/>
              </a:ext>
            </a:extLst>
          </p:cNvPr>
          <p:cNvSpPr txBox="1"/>
          <p:nvPr/>
        </p:nvSpPr>
        <p:spPr>
          <a:xfrm>
            <a:off x="1818314" y="2032985"/>
            <a:ext cx="1534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WT Rh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70459FB-6C8A-2246-E1DC-B284AEAA4782}"/>
              </a:ext>
            </a:extLst>
          </p:cNvPr>
          <p:cNvSpPr txBox="1"/>
          <p:nvPr/>
        </p:nvSpPr>
        <p:spPr>
          <a:xfrm>
            <a:off x="1646793" y="2512560"/>
            <a:ext cx="1705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PLD Rh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46E5C18-4EFD-58F3-862B-BDE73DE5330D}"/>
              </a:ext>
            </a:extLst>
          </p:cNvPr>
          <p:cNvSpPr txBox="1"/>
          <p:nvPr/>
        </p:nvSpPr>
        <p:spPr>
          <a:xfrm>
            <a:off x="1140244" y="2930040"/>
            <a:ext cx="221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PLDmotif</a:t>
            </a:r>
            <a:r>
              <a:rPr lang="en-US" dirty="0"/>
              <a:t> Rho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576A759-298B-913F-90A5-E8E5CF0D09DD}"/>
              </a:ext>
            </a:extLst>
          </p:cNvPr>
          <p:cNvSpPr txBox="1"/>
          <p:nvPr/>
        </p:nvSpPr>
        <p:spPr>
          <a:xfrm>
            <a:off x="1395120" y="3363318"/>
            <a:ext cx="1957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 err="1"/>
              <a:t>kmotif</a:t>
            </a:r>
            <a:r>
              <a:rPr lang="en-US" dirty="0"/>
              <a:t> Rho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F0027C-923F-965C-3FD8-12588980EB35}"/>
              </a:ext>
            </a:extLst>
          </p:cNvPr>
          <p:cNvSpPr txBox="1"/>
          <p:nvPr/>
        </p:nvSpPr>
        <p:spPr>
          <a:xfrm>
            <a:off x="1492529" y="3793597"/>
            <a:ext cx="1872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k1-88 Rh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FA20D46-0B7F-73BD-0CBF-74E11BE9A883}"/>
              </a:ext>
            </a:extLst>
          </p:cNvPr>
          <p:cNvSpPr txBox="1"/>
          <p:nvPr/>
        </p:nvSpPr>
        <p:spPr>
          <a:xfrm>
            <a:off x="962416" y="4652380"/>
            <a:ext cx="2431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Binding buffer only -c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CB284F9-1C66-5DB9-9ED6-F34B9320D6FE}"/>
              </a:ext>
            </a:extLst>
          </p:cNvPr>
          <p:cNvSpPr txBox="1"/>
          <p:nvPr/>
        </p:nvSpPr>
        <p:spPr>
          <a:xfrm>
            <a:off x="1258491" y="4194270"/>
            <a:ext cx="210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10</a:t>
            </a:r>
            <a:r>
              <a:rPr lang="el-GR" dirty="0"/>
              <a:t>μ</a:t>
            </a:r>
            <a:r>
              <a:rPr lang="en-US" dirty="0"/>
              <a:t>M </a:t>
            </a:r>
            <a:r>
              <a:rPr lang="el-GR" dirty="0"/>
              <a:t>Δ</a:t>
            </a:r>
            <a:r>
              <a:rPr lang="en-US" dirty="0"/>
              <a:t>k89-176 Rh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1D278AB-5D59-9A54-804E-8D1F2F3DB948}"/>
              </a:ext>
            </a:extLst>
          </p:cNvPr>
          <p:cNvSpPr txBox="1"/>
          <p:nvPr/>
        </p:nvSpPr>
        <p:spPr>
          <a:xfrm>
            <a:off x="3468755" y="5210120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highlight>
                  <a:srgbClr val="FFFF00"/>
                </a:highlight>
              </a:rPr>
              <a:t>Rep 3</a:t>
            </a:r>
          </a:p>
        </p:txBody>
      </p:sp>
    </p:spTree>
    <p:extLst>
      <p:ext uri="{BB962C8B-B14F-4D97-AF65-F5344CB8AC3E}">
        <p14:creationId xmlns:p14="http://schemas.microsoft.com/office/powerpoint/2010/main" val="3624173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dd8cbebb-2139-4df8-b411-4e3e87abeb5c}" enabled="0" method="" siteId="{dd8cbebb-2139-4df8-b411-4e3e87abeb5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147</Words>
  <Application>Microsoft Macintosh PowerPoint</Application>
  <PresentationFormat>Widescreen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ypotou, Aimilia</dc:creator>
  <cp:lastModifiedBy>Krypotou, Aimilia</cp:lastModifiedBy>
  <cp:revision>1</cp:revision>
  <dcterms:created xsi:type="dcterms:W3CDTF">2025-12-06T18:43:48Z</dcterms:created>
  <dcterms:modified xsi:type="dcterms:W3CDTF">2025-12-29T17:56:25Z</dcterms:modified>
</cp:coreProperties>
</file>